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8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27" autoAdjust="0"/>
    <p:restoredTop sz="94660"/>
  </p:normalViewPr>
  <p:slideViewPr>
    <p:cSldViewPr snapToGrid="0">
      <p:cViewPr>
        <p:scale>
          <a:sx n="125" d="100"/>
          <a:sy n="125" d="100"/>
        </p:scale>
        <p:origin x="12" y="-19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39751" y="1050449"/>
            <a:ext cx="6480175" cy="1834852"/>
            <a:chOff x="539751" y="2650649"/>
            <a:chExt cx="6480175" cy="1834852"/>
          </a:xfrm>
        </p:grpSpPr>
        <p:sp>
          <p:nvSpPr>
            <p:cNvPr id="19" name="矩形 18"/>
            <p:cNvSpPr/>
            <p:nvPr/>
          </p:nvSpPr>
          <p:spPr>
            <a:xfrm>
              <a:off x="539751" y="2650649"/>
              <a:ext cx="6480175" cy="18348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  <p:pic>
          <p:nvPicPr>
            <p:cNvPr id="23" name="Stage vs TBR.tiff" descr="Stage vs TBR.tiff"/>
            <p:cNvPicPr>
              <a:picLocks noChangeAspect="1"/>
            </p:cNvPicPr>
            <p:nvPr/>
          </p:nvPicPr>
          <p:blipFill rotWithShape="1">
            <a:blip r:embed="rId2">
              <a:extLst/>
            </a:blip>
            <a:srcRect r="13595" b="15425"/>
            <a:stretch/>
          </p:blipFill>
          <p:spPr>
            <a:xfrm>
              <a:off x="871700" y="2666253"/>
              <a:ext cx="1736881" cy="1522366"/>
            </a:xfrm>
            <a:prstGeom prst="rect">
              <a:avLst/>
            </a:prstGeom>
            <a:ln w="12700">
              <a:miter lim="400000"/>
            </a:ln>
          </p:spPr>
        </p:pic>
        <p:pic>
          <p:nvPicPr>
            <p:cNvPr id="24" name="Stage vs PETCT.tiff" descr="Stage vs PETCT.tiff"/>
            <p:cNvPicPr>
              <a:picLocks noChangeAspect="1"/>
            </p:cNvPicPr>
            <p:nvPr/>
          </p:nvPicPr>
          <p:blipFill rotWithShape="1">
            <a:blip r:embed="rId3">
              <a:extLst/>
            </a:blip>
            <a:srcRect r="12812" b="15050"/>
            <a:stretch/>
          </p:blipFill>
          <p:spPr>
            <a:xfrm>
              <a:off x="2790504" y="2678575"/>
              <a:ext cx="1753556" cy="1529095"/>
            </a:xfrm>
            <a:prstGeom prst="rect">
              <a:avLst/>
            </a:prstGeom>
            <a:ln w="12700">
              <a:miter lim="400000"/>
            </a:ln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001" b="14689"/>
            <a:stretch/>
          </p:blipFill>
          <p:spPr>
            <a:xfrm>
              <a:off x="4730822" y="2662469"/>
              <a:ext cx="1760148" cy="1545200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754910" y="2657325"/>
              <a:ext cx="2916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2264EA60-B72B-42CB-AC68-E016DADC16C0}"/>
                </a:ext>
              </a:extLst>
            </p:cNvPr>
            <p:cNvSpPr txBox="1"/>
            <p:nvPr/>
          </p:nvSpPr>
          <p:spPr>
            <a:xfrm>
              <a:off x="2612221" y="2656249"/>
              <a:ext cx="274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4579998" y="2656936"/>
              <a:ext cx="3062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381774" y="4137860"/>
              <a:ext cx="2184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581798" y="4137860"/>
              <a:ext cx="27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776108" y="4137860"/>
              <a:ext cx="3365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985658" y="4137860"/>
              <a:ext cx="3889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249184" y="4140400"/>
              <a:ext cx="3136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00" r="13001" b="827"/>
            <a:stretch/>
          </p:blipFill>
          <p:spPr>
            <a:xfrm>
              <a:off x="4734632" y="4321969"/>
              <a:ext cx="1760148" cy="13716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00" r="13001" b="827"/>
            <a:stretch/>
          </p:blipFill>
          <p:spPr>
            <a:xfrm>
              <a:off x="2788700" y="4321969"/>
              <a:ext cx="1760148" cy="13716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00" r="13001" b="827"/>
            <a:stretch/>
          </p:blipFill>
          <p:spPr>
            <a:xfrm>
              <a:off x="872843" y="4321969"/>
              <a:ext cx="1760148" cy="137160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/>
          </p:nvSpPr>
          <p:spPr>
            <a:xfrm>
              <a:off x="3302014" y="4137860"/>
              <a:ext cx="2184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502038" y="4137860"/>
              <a:ext cx="27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3696348" y="4137860"/>
              <a:ext cx="3365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3905898" y="4137860"/>
              <a:ext cx="3889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4161804" y="4140400"/>
              <a:ext cx="3289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5252734" y="4137860"/>
              <a:ext cx="2184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5452758" y="4137860"/>
              <a:ext cx="27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5647068" y="4137860"/>
              <a:ext cx="3365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856618" y="4137860"/>
              <a:ext cx="3889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IIb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115064" y="4140400"/>
              <a:ext cx="325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文本框 40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82646" y="3040928"/>
            <a:ext cx="661157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istribution of TBR values, PET/CT or MSS indicated LME ranges regarding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 clinical stages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sults showed no significant correlations was found, indicating that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 clinical stages e were not TBR-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r LME range-influencing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actor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 this study.</a:t>
            </a:r>
          </a:p>
        </p:txBody>
      </p:sp>
    </p:spTree>
    <p:extLst>
      <p:ext uri="{BB962C8B-B14F-4D97-AF65-F5344CB8AC3E}">
        <p14:creationId xmlns:p14="http://schemas.microsoft.com/office/powerpoint/2010/main" val="3601907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63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黑体</vt:lpstr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3:30Z</dcterms:modified>
</cp:coreProperties>
</file>